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C4D17-AEE8-48C8-8291-95EACEA462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AC744-42F6-43D3-BABB-375B0BB079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3BE898-3398-4EA7-A438-DB2B030A811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7406A-84F5-4117-A4FD-5EEC4278F5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FFFF91-423B-40AD-93A3-D4A33FD721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382887-BEDA-44E6-A114-85FAD1DA3B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888EF-2519-497C-8C03-327292CCED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922A6-3A5A-4AAE-99E0-B916B9B7B0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67DDD-9C27-4145-A063-73A67A5EAD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958172-3157-4F1C-9212-DB33AB264C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708EC5-42CD-4D34-AC3E-24BD315C4A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CB977B-EBC8-4D5D-BF87-13261A7451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B6D568-A076-4192-AB60-443676B2679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505320" y="914400"/>
            <a:ext cx="2339640" cy="1709640"/>
            <a:chOff x="3505320" y="914400"/>
            <a:chExt cx="2339640" cy="1709640"/>
          </a:xfrm>
        </p:grpSpPr>
        <p:sp>
          <p:nvSpPr>
            <p:cNvPr id="42" name=""/>
            <p:cNvSpPr/>
            <p:nvPr/>
          </p:nvSpPr>
          <p:spPr>
            <a:xfrm>
              <a:off x="3505320" y="914400"/>
              <a:ext cx="233964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flipV="1">
              <a:off x="3759480" y="1162440"/>
              <a:ext cx="1800" cy="103320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854880" y="1516320"/>
              <a:ext cx="128520" cy="679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857760" y="1519560"/>
              <a:ext cx="122760" cy="6732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173840" y="1423440"/>
              <a:ext cx="130320" cy="772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176720" y="1426680"/>
              <a:ext cx="124200" cy="7660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494600" y="1741320"/>
              <a:ext cx="130320" cy="454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497840" y="1744560"/>
              <a:ext cx="124200" cy="4482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815360" y="1596600"/>
              <a:ext cx="128880" cy="599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818600" y="1599840"/>
              <a:ext cx="122400" cy="5929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135760" y="1536840"/>
              <a:ext cx="127440" cy="658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139000" y="1540080"/>
              <a:ext cx="120960" cy="6526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454720" y="1702080"/>
              <a:ext cx="128880" cy="493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457960" y="1705320"/>
              <a:ext cx="122400" cy="4874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3917880" y="1317960"/>
              <a:ext cx="1440" cy="197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896640" y="1318320"/>
              <a:ext cx="4320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4238280" y="1258560"/>
              <a:ext cx="1440" cy="164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217400" y="1258560"/>
              <a:ext cx="432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4559040" y="1536480"/>
              <a:ext cx="1440" cy="204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537800" y="1536840"/>
              <a:ext cx="4320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4879440" y="1366920"/>
              <a:ext cx="1800" cy="229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858920" y="1367280"/>
              <a:ext cx="4320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5198760" y="1470600"/>
              <a:ext cx="1800" cy="65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080" bIns="19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177880" y="1470960"/>
              <a:ext cx="417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5517720" y="1643760"/>
              <a:ext cx="1800" cy="57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160" bIns="11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496840" y="1644120"/>
              <a:ext cx="4320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759480" y="1162440"/>
              <a:ext cx="1800" cy="1033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743280" y="219600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743280" y="206712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743280" y="193644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743280" y="180900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743280" y="168012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743280" y="154944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743280" y="142200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743280" y="128988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743280" y="116244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759480" y="2196000"/>
              <a:ext cx="191772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V="1">
              <a:off x="3759480" y="2195640"/>
              <a:ext cx="180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4080240" y="219564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4401000" y="2195640"/>
              <a:ext cx="180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4720320" y="219564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5040720" y="2195640"/>
              <a:ext cx="180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5359680" y="2195640"/>
              <a:ext cx="180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V="1">
              <a:off x="5680800" y="219564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601520" y="962640"/>
              <a:ext cx="285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1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677400" y="21488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632040" y="20214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677400" y="18907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632040" y="17618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677400" y="1632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632040" y="15022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677400" y="13752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632040" y="12445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677400" y="1115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rot="5400000">
              <a:off x="3835440" y="232308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rot="5400000">
              <a:off x="3808800" y="228852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5400000">
              <a:off x="4159080" y="2355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rot="5400000">
              <a:off x="4084200" y="23601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rot="5400000">
              <a:off x="4098240" y="228132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rot="5400000">
              <a:off x="4479480" y="2355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rot="5400000">
              <a:off x="4406400" y="23601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rot="5400000">
              <a:off x="4410720" y="22914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rot="5400000">
              <a:off x="4790160" y="236952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5400000">
              <a:off x="4727160" y="23601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rot="5400000">
              <a:off x="4725360" y="229608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rot="5400000">
              <a:off x="5117760" y="2355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rot="5400000">
              <a:off x="5046120" y="23601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rot="5400000">
              <a:off x="5003280" y="233712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rot="5400000">
              <a:off x="5438520" y="2355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rot="5400000">
              <a:off x="5412600" y="231444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rot="5400000">
              <a:off x="5346000" y="231516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rot="16200000">
              <a:off x="3418200" y="162684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4" name=""/>
          <p:cNvGrpSpPr/>
          <p:nvPr/>
        </p:nvGrpSpPr>
        <p:grpSpPr>
          <a:xfrm>
            <a:off x="762120" y="2819520"/>
            <a:ext cx="2340000" cy="1709640"/>
            <a:chOff x="762120" y="2819520"/>
            <a:chExt cx="2340000" cy="1709640"/>
          </a:xfrm>
        </p:grpSpPr>
        <p:sp>
          <p:nvSpPr>
            <p:cNvPr id="115" name=""/>
            <p:cNvSpPr/>
            <p:nvPr/>
          </p:nvSpPr>
          <p:spPr>
            <a:xfrm>
              <a:off x="762120" y="2819520"/>
              <a:ext cx="234000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 flipV="1">
              <a:off x="1018440" y="3039120"/>
              <a:ext cx="1440" cy="105048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113120" y="3268080"/>
              <a:ext cx="124200" cy="821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116360" y="3271320"/>
              <a:ext cx="118080" cy="8150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423800" y="3463920"/>
              <a:ext cx="124200" cy="625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427040" y="3467160"/>
              <a:ext cx="117720" cy="6192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735920" y="3623400"/>
              <a:ext cx="124200" cy="466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738800" y="3626640"/>
              <a:ext cx="117720" cy="4597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047680" y="3557160"/>
              <a:ext cx="126000" cy="532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050920" y="3560400"/>
              <a:ext cx="119520" cy="5259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359800" y="3483000"/>
              <a:ext cx="124200" cy="606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363040" y="3486240"/>
              <a:ext cx="118080" cy="6001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2671560" y="3683520"/>
              <a:ext cx="124560" cy="405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674800" y="3686760"/>
              <a:ext cx="118080" cy="3992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flipV="1">
              <a:off x="1174680" y="3139560"/>
              <a:ext cx="1080" cy="127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1152360" y="3139920"/>
              <a:ext cx="442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flipV="1">
              <a:off x="1485360" y="3310560"/>
              <a:ext cx="1080" cy="153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464480" y="3310560"/>
              <a:ext cx="442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1797120" y="3421080"/>
              <a:ext cx="1080" cy="201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776600" y="3421440"/>
              <a:ext cx="4284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2109240" y="3379680"/>
              <a:ext cx="1080" cy="176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086920" y="3380040"/>
              <a:ext cx="442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flipV="1">
              <a:off x="2421000" y="3419640"/>
              <a:ext cx="1080" cy="63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400840" y="3419640"/>
              <a:ext cx="43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2733120" y="3530160"/>
              <a:ext cx="1440" cy="153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712600" y="3530160"/>
              <a:ext cx="424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018440" y="3039120"/>
              <a:ext cx="1440" cy="1050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002960" y="408960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002960" y="395856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002960" y="382752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002960" y="369612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002960" y="356508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1002960" y="343080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002960" y="330120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002960" y="317016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1002960" y="303912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018440" y="4089600"/>
              <a:ext cx="187524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V="1">
              <a:off x="1018440" y="40892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1330920" y="408924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1642680" y="408924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flipV="1">
              <a:off x="1953000" y="40892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2266920" y="408924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 flipV="1">
              <a:off x="2578680" y="408924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2889360" y="408924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1814760" y="2868120"/>
              <a:ext cx="392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18/1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911160" y="4031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867960" y="3900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911160" y="37688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867960" y="3639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911160" y="35082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867960" y="33739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911160" y="32428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867960" y="31118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911160" y="29804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 rot="5400000">
              <a:off x="1095840" y="422028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 rot="5400000">
              <a:off x="1067400" y="418500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rot="5400000">
              <a:off x="1408320" y="42544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rot="5400000">
              <a:off x="1336320" y="42598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rot="5400000">
              <a:off x="1348560" y="418104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 rot="5400000">
              <a:off x="1720440" y="42544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rot="5400000">
              <a:off x="1650240" y="42598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rot="5400000">
              <a:off x="1652400" y="41896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rot="5400000">
              <a:off x="2020320" y="426348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rot="5400000">
              <a:off x="1959120" y="42598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rot="5400000">
              <a:off x="1958760" y="419760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rot="5400000">
              <a:off x="2342880" y="42544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rot="5400000">
              <a:off x="2272680" y="42598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rot="5400000">
              <a:off x="2228040" y="423648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 rot="5400000">
              <a:off x="2655000" y="42544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 rot="5400000">
              <a:off x="2630880" y="421524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 rot="5400000">
              <a:off x="2562120" y="421596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 rot="16200000">
              <a:off x="674280" y="352152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7" name=""/>
          <p:cNvGrpSpPr/>
          <p:nvPr/>
        </p:nvGrpSpPr>
        <p:grpSpPr>
          <a:xfrm>
            <a:off x="3505320" y="2819520"/>
            <a:ext cx="2339640" cy="1709640"/>
            <a:chOff x="3505320" y="2819520"/>
            <a:chExt cx="2339640" cy="1709640"/>
          </a:xfrm>
        </p:grpSpPr>
        <p:sp>
          <p:nvSpPr>
            <p:cNvPr id="188" name=""/>
            <p:cNvSpPr/>
            <p:nvPr/>
          </p:nvSpPr>
          <p:spPr>
            <a:xfrm>
              <a:off x="3505320" y="2819520"/>
              <a:ext cx="233964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 flipV="1">
              <a:off x="3745080" y="3060000"/>
              <a:ext cx="1800" cy="104004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3842640" y="3435480"/>
              <a:ext cx="127800" cy="664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3845880" y="3438720"/>
              <a:ext cx="121680" cy="6584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4165200" y="3895200"/>
              <a:ext cx="129600" cy="204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4168440" y="3898440"/>
              <a:ext cx="123120" cy="1983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4489920" y="3988800"/>
              <a:ext cx="129600" cy="111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4493160" y="3991680"/>
              <a:ext cx="123120" cy="105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4814280" y="3887640"/>
              <a:ext cx="131400" cy="212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4817880" y="3890880"/>
              <a:ext cx="124920" cy="2062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5140800" y="3788640"/>
              <a:ext cx="127800" cy="311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5144040" y="3791520"/>
              <a:ext cx="121320" cy="3056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5465520" y="3958560"/>
              <a:ext cx="127800" cy="141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5468400" y="3961800"/>
              <a:ext cx="121680" cy="1353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3906000" y="3194280"/>
              <a:ext cx="1440" cy="241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3884760" y="3194280"/>
              <a:ext cx="435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flipV="1">
              <a:off x="4228560" y="3847680"/>
              <a:ext cx="1800" cy="47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" bIns="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207680" y="3848040"/>
              <a:ext cx="435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 flipV="1">
              <a:off x="4555080" y="3977640"/>
              <a:ext cx="1440" cy="10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533480" y="3977640"/>
              <a:ext cx="439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 flipV="1">
              <a:off x="4879440" y="3831120"/>
              <a:ext cx="1440" cy="56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858200" y="3831120"/>
              <a:ext cx="439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 flipV="1">
              <a:off x="5204160" y="3674520"/>
              <a:ext cx="1440" cy="113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5182920" y="3674880"/>
              <a:ext cx="42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 flipV="1">
              <a:off x="5528520" y="3933360"/>
              <a:ext cx="1440" cy="25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5507280" y="3933360"/>
              <a:ext cx="435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3745080" y="3060360"/>
              <a:ext cx="1800" cy="1040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3728880" y="410040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3728880" y="395208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3728880" y="380232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3728880" y="365436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3728880" y="350604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3728880" y="335808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3728880" y="3208680"/>
              <a:ext cx="1584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3728880" y="3060360"/>
              <a:ext cx="158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3745080" y="4100400"/>
              <a:ext cx="1950480" cy="108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 flipV="1">
              <a:off x="3745080" y="410004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V="1">
              <a:off x="4069800" y="410004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 flipV="1">
              <a:off x="4394160" y="410004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 flipV="1">
              <a:off x="4717440" y="41000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 flipV="1">
              <a:off x="5043240" y="410004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 flipV="1">
              <a:off x="5367960" y="410004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 flipV="1">
              <a:off x="5692320" y="41000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4592880" y="2868120"/>
              <a:ext cx="285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2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3674880" y="40514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674880" y="39016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3645360" y="37537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3645360" y="360540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3645360" y="34574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3645360" y="33080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3645360" y="315972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3645360" y="301176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rot="5400000">
              <a:off x="3827880" y="423072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rot="5400000">
              <a:off x="3796920" y="419328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rot="5400000">
              <a:off x="4153680" y="4263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rot="5400000">
              <a:off x="4080240" y="42660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rot="5400000">
              <a:off x="4093920" y="418896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rot="5400000">
              <a:off x="4478040" y="4263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rot="5400000">
              <a:off x="4404600" y="42660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rot="5400000">
              <a:off x="4408200" y="41994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rot="5400000">
              <a:off x="4792320" y="427608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 rot="5400000">
              <a:off x="4729320" y="42660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 rot="5400000">
              <a:off x="4727880" y="420408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 rot="5400000">
              <a:off x="5125320" y="4263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 rot="5400000">
              <a:off x="5053320" y="42660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 rot="5400000">
              <a:off x="5010120" y="424188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 rot="5400000">
              <a:off x="5450040" y="4263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 rot="5400000">
              <a:off x="5424120" y="422208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 rot="5400000">
              <a:off x="5356800" y="422136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 rot="16200000">
              <a:off x="3411720" y="353520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8" name=""/>
          <p:cNvGrpSpPr/>
          <p:nvPr/>
        </p:nvGrpSpPr>
        <p:grpSpPr>
          <a:xfrm>
            <a:off x="762120" y="4800600"/>
            <a:ext cx="2340000" cy="1709640"/>
            <a:chOff x="762120" y="4800600"/>
            <a:chExt cx="2340000" cy="1709640"/>
          </a:xfrm>
        </p:grpSpPr>
        <p:sp>
          <p:nvSpPr>
            <p:cNvPr id="259" name=""/>
            <p:cNvSpPr/>
            <p:nvPr/>
          </p:nvSpPr>
          <p:spPr>
            <a:xfrm>
              <a:off x="762120" y="4800600"/>
              <a:ext cx="234000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 flipV="1">
              <a:off x="1004760" y="5014080"/>
              <a:ext cx="1080" cy="109296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1098000" y="5489280"/>
              <a:ext cx="126720" cy="618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1101240" y="5492520"/>
              <a:ext cx="120240" cy="6116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1415160" y="5706360"/>
              <a:ext cx="126720" cy="400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1418400" y="5709240"/>
              <a:ext cx="120240" cy="3945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1732320" y="5709240"/>
              <a:ext cx="126720" cy="397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1735560" y="5712480"/>
              <a:ext cx="120240" cy="3913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2048040" y="5817960"/>
              <a:ext cx="126360" cy="289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2050920" y="5820840"/>
              <a:ext cx="120600" cy="2829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2364840" y="5812920"/>
              <a:ext cx="124920" cy="294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2367720" y="5816160"/>
              <a:ext cx="118800" cy="2876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2680200" y="5720400"/>
              <a:ext cx="128160" cy="3870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2683440" y="5723640"/>
              <a:ext cx="121680" cy="3805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 flipV="1">
              <a:off x="1159920" y="5216760"/>
              <a:ext cx="1440" cy="27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1140840" y="5217120"/>
              <a:ext cx="41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 flipV="1">
              <a:off x="1478880" y="5498280"/>
              <a:ext cx="1080" cy="207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1458000" y="5498640"/>
              <a:ext cx="41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 flipV="1">
              <a:off x="1794240" y="5555160"/>
              <a:ext cx="1080" cy="154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1775160" y="5555160"/>
              <a:ext cx="41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 flipV="1">
              <a:off x="2111040" y="5700960"/>
              <a:ext cx="1080" cy="116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2090520" y="5701320"/>
              <a:ext cx="406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 flipV="1">
              <a:off x="2426760" y="5509080"/>
              <a:ext cx="1080" cy="303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2407680" y="5509440"/>
              <a:ext cx="406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 flipV="1">
              <a:off x="2743560" y="5566320"/>
              <a:ext cx="1440" cy="154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2723040" y="5566320"/>
              <a:ext cx="4104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1004760" y="5014080"/>
              <a:ext cx="1080" cy="1092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988920" y="610740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988920" y="597024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988920" y="583380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988920" y="569664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988920" y="556164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988920" y="542304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988920" y="528804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988920" y="514980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988920" y="501408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1004760" y="6107400"/>
              <a:ext cx="1894320" cy="108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 flipV="1">
              <a:off x="1004760" y="6107040"/>
              <a:ext cx="108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 flipV="1">
              <a:off x="1320120" y="6107040"/>
              <a:ext cx="108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 flipV="1">
              <a:off x="1638720" y="6107040"/>
              <a:ext cx="108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 flipV="1">
              <a:off x="1954080" y="6107040"/>
              <a:ext cx="144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 flipV="1">
              <a:off x="2269800" y="6107040"/>
              <a:ext cx="108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 flipV="1">
              <a:off x="2586600" y="6107040"/>
              <a:ext cx="108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 flipV="1">
              <a:off x="2903760" y="6107040"/>
              <a:ext cx="1080" cy="21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1878480" y="4847400"/>
              <a:ext cx="285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2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920160" y="60584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877320" y="59234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877320" y="57848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877320" y="56498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877320" y="5512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877320" y="5376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877320" y="52390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877320" y="51008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877320" y="49654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 rot="5400000">
              <a:off x="1076400" y="623268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 rot="5400000">
              <a:off x="1053720" y="619956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 rot="5400000">
              <a:off x="1394280" y="62686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 rot="5400000">
              <a:off x="1323720" y="627264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 rot="5400000">
              <a:off x="1341720" y="619560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 rot="5400000">
              <a:off x="1711080" y="62686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 rot="5400000">
              <a:off x="1642320" y="627264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 rot="5400000">
              <a:off x="1650600" y="62028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 rot="5400000">
              <a:off x="2017800" y="627912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 rot="5400000">
              <a:off x="1957680" y="627264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 rot="5400000">
              <a:off x="1960200" y="620748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 rot="5400000">
              <a:off x="2343600" y="62686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 rot="5400000">
              <a:off x="2274840" y="627264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 rot="5400000">
              <a:off x="2234520" y="625104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 rot="5400000">
              <a:off x="2659320" y="62686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 rot="5400000">
              <a:off x="2637720" y="622584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 rot="5400000">
              <a:off x="2573280" y="622620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 rot="16200000">
              <a:off x="658440" y="550656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1" name=""/>
          <p:cNvGrpSpPr/>
          <p:nvPr/>
        </p:nvGrpSpPr>
        <p:grpSpPr>
          <a:xfrm>
            <a:off x="3505320" y="4800600"/>
            <a:ext cx="2339640" cy="1709640"/>
            <a:chOff x="3505320" y="4800600"/>
            <a:chExt cx="2339640" cy="1709640"/>
          </a:xfrm>
        </p:grpSpPr>
        <p:sp>
          <p:nvSpPr>
            <p:cNvPr id="332" name=""/>
            <p:cNvSpPr/>
            <p:nvPr/>
          </p:nvSpPr>
          <p:spPr>
            <a:xfrm>
              <a:off x="3505320" y="4800600"/>
              <a:ext cx="233964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 flipV="1">
              <a:off x="3696840" y="5041080"/>
              <a:ext cx="1440" cy="106272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3796560" y="5754240"/>
              <a:ext cx="130680" cy="34920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3799800" y="5757480"/>
              <a:ext cx="123840" cy="3427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4125240" y="6015600"/>
              <a:ext cx="130320" cy="8784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4128480" y="6018840"/>
              <a:ext cx="123480" cy="8172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4453920" y="5828040"/>
              <a:ext cx="130320" cy="275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4456800" y="5831280"/>
              <a:ext cx="123840" cy="2689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4782240" y="5656320"/>
              <a:ext cx="132120" cy="44712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4785480" y="5659560"/>
              <a:ext cx="125280" cy="4406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5112360" y="5533920"/>
              <a:ext cx="130320" cy="569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5115600" y="5536800"/>
              <a:ext cx="123480" cy="5634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5441040" y="5630040"/>
              <a:ext cx="130320" cy="473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5444280" y="5632920"/>
              <a:ext cx="123480" cy="4676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 flipV="1">
              <a:off x="3861000" y="5615640"/>
              <a:ext cx="1440" cy="138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3841920" y="561564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 flipV="1">
              <a:off x="4189320" y="5932080"/>
              <a:ext cx="1800" cy="83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720" bIns="36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4170240" y="5932080"/>
              <a:ext cx="40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 flipV="1">
              <a:off x="4518000" y="5576040"/>
              <a:ext cx="1440" cy="251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4498920" y="557640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 flipV="1">
              <a:off x="4848120" y="5152320"/>
              <a:ext cx="1440" cy="503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4829040" y="515268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 flipV="1">
              <a:off x="5176800" y="5109840"/>
              <a:ext cx="1440" cy="423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5157360" y="5110200"/>
              <a:ext cx="39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 flipV="1">
              <a:off x="5505120" y="5366880"/>
              <a:ext cx="1800" cy="262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5485680" y="5366880"/>
              <a:ext cx="399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3696840" y="5041080"/>
              <a:ext cx="1440" cy="10627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3682080" y="6103800"/>
              <a:ext cx="1440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3682080" y="5951160"/>
              <a:ext cx="1440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3682080" y="5799960"/>
              <a:ext cx="1440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3682080" y="5647320"/>
              <a:ext cx="1440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3682080" y="5497560"/>
              <a:ext cx="1440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3682080" y="5344920"/>
              <a:ext cx="14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3682080" y="5193720"/>
              <a:ext cx="1440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3682080" y="5041080"/>
              <a:ext cx="1440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3696840" y="6103800"/>
              <a:ext cx="1970640" cy="108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 flipV="1">
              <a:off x="3696840" y="61034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 flipV="1">
              <a:off x="4025520" y="61034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 flipV="1">
              <a:off x="4353840" y="610344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 flipV="1">
              <a:off x="4682520" y="61034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 flipV="1">
              <a:off x="5012640" y="61034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 flipV="1">
              <a:off x="5340960" y="6103440"/>
              <a:ext cx="180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 flipV="1">
              <a:off x="5669640" y="61034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4529880" y="4847400"/>
              <a:ext cx="285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2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3621240" y="60566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3621240" y="59022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3621240" y="57524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3621240" y="5600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3621240" y="54486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3621240" y="52963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3621240" y="5146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3621240" y="49939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 rot="5400000">
              <a:off x="3777480" y="623088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 rot="5400000">
              <a:off x="3756960" y="619488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 rot="5400000">
              <a:off x="4105440" y="626580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 rot="5400000">
              <a:off x="4038840" y="62679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 rot="5400000">
              <a:off x="4056120" y="619092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 rot="5400000">
              <a:off x="4433760" y="626580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 rot="5400000">
              <a:off x="4367520" y="62679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 rot="5400000">
              <a:off x="4376160" y="62010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 rot="5400000">
              <a:off x="4752000" y="627768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 rot="5400000">
              <a:off x="4695840" y="62679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 rot="5400000">
              <a:off x="4698720" y="620424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 rot="5400000">
              <a:off x="5090760" y="626580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 rot="5400000">
              <a:off x="5023800" y="62679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 rot="5400000">
              <a:off x="4986000" y="624744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 rot="5400000">
              <a:off x="5419440" y="626580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 rot="5400000">
              <a:off x="5400000" y="622404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 rot="5400000">
              <a:off x="5336640" y="622476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 rot="16200000">
              <a:off x="3405240" y="552240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02" name=""/>
          <p:cNvGrpSpPr/>
          <p:nvPr/>
        </p:nvGrpSpPr>
        <p:grpSpPr>
          <a:xfrm>
            <a:off x="762120" y="6705720"/>
            <a:ext cx="2340000" cy="1709640"/>
            <a:chOff x="762120" y="6705720"/>
            <a:chExt cx="2340000" cy="1709640"/>
          </a:xfrm>
        </p:grpSpPr>
        <p:sp>
          <p:nvSpPr>
            <p:cNvPr id="403" name=""/>
            <p:cNvSpPr/>
            <p:nvPr/>
          </p:nvSpPr>
          <p:spPr>
            <a:xfrm>
              <a:off x="762120" y="6705720"/>
              <a:ext cx="234000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 flipV="1">
              <a:off x="1001520" y="6899040"/>
              <a:ext cx="1080" cy="111312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1094400" y="7468200"/>
              <a:ext cx="126000" cy="5439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1097640" y="7471440"/>
              <a:ext cx="119520" cy="537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1407960" y="7553160"/>
              <a:ext cx="127440" cy="4590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1410840" y="7556400"/>
              <a:ext cx="121320" cy="4528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1723320" y="7738560"/>
              <a:ext cx="124200" cy="273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1726200" y="7741800"/>
              <a:ext cx="118080" cy="2671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2035080" y="7517160"/>
              <a:ext cx="125640" cy="49500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2038320" y="7520040"/>
              <a:ext cx="119520" cy="4892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2350440" y="7554600"/>
              <a:ext cx="125640" cy="4575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2353320" y="7557840"/>
              <a:ext cx="119880" cy="4514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2663640" y="7581240"/>
              <a:ext cx="126000" cy="43092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2666880" y="7584480"/>
              <a:ext cx="119520" cy="4244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 flipV="1">
              <a:off x="1157040" y="7362360"/>
              <a:ext cx="1440" cy="105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1135440" y="7362720"/>
              <a:ext cx="43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 flipV="1">
              <a:off x="1470960" y="7445880"/>
              <a:ext cx="1080" cy="106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1450440" y="7446240"/>
              <a:ext cx="424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 flipV="1">
              <a:off x="1784880" y="7672320"/>
              <a:ext cx="1080" cy="65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080" bIns="19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1764000" y="7672680"/>
              <a:ext cx="442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 flipV="1">
              <a:off x="2098080" y="7312680"/>
              <a:ext cx="1080" cy="204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2077920" y="7312680"/>
              <a:ext cx="424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 flipV="1">
              <a:off x="2412000" y="7513920"/>
              <a:ext cx="1080" cy="40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2391120" y="7513920"/>
              <a:ext cx="424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 flipV="1">
              <a:off x="2727000" y="7416360"/>
              <a:ext cx="1080" cy="164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2705040" y="7416360"/>
              <a:ext cx="43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1001520" y="6899040"/>
              <a:ext cx="1080" cy="1113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985680" y="801252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985680" y="782676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985680" y="764136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985680" y="745596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985680" y="727020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985680" y="708480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985680" y="689904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1001520" y="8012520"/>
              <a:ext cx="1883160" cy="108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 flipV="1">
              <a:off x="1001520" y="8012520"/>
              <a:ext cx="1080" cy="21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 flipV="1">
              <a:off x="1314720" y="8012520"/>
              <a:ext cx="1440" cy="21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 flipV="1">
              <a:off x="1630080" y="8012520"/>
              <a:ext cx="1440" cy="21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 flipV="1">
              <a:off x="1942200" y="8012520"/>
              <a:ext cx="1080" cy="21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 flipV="1">
              <a:off x="2255760" y="8012520"/>
              <a:ext cx="1080" cy="21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 flipV="1">
              <a:off x="2570760" y="8012520"/>
              <a:ext cx="1080" cy="21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 flipV="1">
              <a:off x="2884680" y="8012520"/>
              <a:ext cx="1080" cy="21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1815120" y="6752520"/>
              <a:ext cx="285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2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931680" y="7963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931680" y="7778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931680" y="75924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931680" y="74070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931680" y="72216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902520" y="70358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902520" y="685044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 rot="5400000">
              <a:off x="1073520" y="813924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 rot="5400000">
              <a:off x="1046880" y="810324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 rot="5400000">
              <a:off x="1389600" y="817416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 rot="5400000">
              <a:off x="1317960" y="81763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 rot="5400000">
              <a:off x="1331640" y="810108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 rot="5400000">
              <a:off x="1702440" y="817416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 rot="5400000">
              <a:off x="1629720" y="81763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 rot="5400000">
              <a:off x="1633680" y="810972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 rot="5400000">
              <a:off x="2006280" y="818604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 rot="5400000">
              <a:off x="1945080" y="81763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 rot="5400000">
              <a:off x="1942920" y="811296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 rot="5400000">
              <a:off x="2331720" y="817416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 rot="5400000">
              <a:off x="2258280" y="81763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 rot="5400000">
              <a:off x="2215440" y="815796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 rot="5400000">
              <a:off x="2645280" y="817416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 rot="5400000">
              <a:off x="2619720" y="813096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 rot="5400000">
              <a:off x="2552400" y="813168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 rot="16200000">
              <a:off x="677520" y="740088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1" name=""/>
          <p:cNvGrpSpPr/>
          <p:nvPr/>
        </p:nvGrpSpPr>
        <p:grpSpPr>
          <a:xfrm>
            <a:off x="762120" y="914400"/>
            <a:ext cx="2340000" cy="1709640"/>
            <a:chOff x="762120" y="914400"/>
            <a:chExt cx="2340000" cy="1709640"/>
          </a:xfrm>
        </p:grpSpPr>
        <p:sp>
          <p:nvSpPr>
            <p:cNvPr id="472" name=""/>
            <p:cNvSpPr/>
            <p:nvPr/>
          </p:nvSpPr>
          <p:spPr>
            <a:xfrm>
              <a:off x="762120" y="914400"/>
              <a:ext cx="234000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 flipV="1">
              <a:off x="1004760" y="1153440"/>
              <a:ext cx="1080" cy="98244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1097640" y="1749960"/>
              <a:ext cx="126000" cy="385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1100880" y="1753200"/>
              <a:ext cx="119520" cy="3798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1410840" y="2054520"/>
              <a:ext cx="126000" cy="81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1414080" y="2057760"/>
              <a:ext cx="119520" cy="752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1726200" y="2026080"/>
              <a:ext cx="124560" cy="110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1729440" y="2028960"/>
              <a:ext cx="118080" cy="1040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2039760" y="2049840"/>
              <a:ext cx="126000" cy="8640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0" bIns="39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2043000" y="2052720"/>
              <a:ext cx="119520" cy="802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2355120" y="2044800"/>
              <a:ext cx="126000" cy="9144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640" bIns="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2358360" y="2048040"/>
              <a:ext cx="119520" cy="849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160" bIns="38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2668320" y="2030760"/>
              <a:ext cx="126000" cy="105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2671560" y="2034000"/>
              <a:ext cx="119520" cy="990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 flipV="1">
              <a:off x="1158840" y="1711800"/>
              <a:ext cx="1080" cy="37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1140120" y="1712160"/>
              <a:ext cx="4104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 flipV="1">
              <a:off x="1474200" y="2044800"/>
              <a:ext cx="1080" cy="9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1455120" y="2044800"/>
              <a:ext cx="41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 flipV="1">
              <a:off x="1785960" y="2019240"/>
              <a:ext cx="1080" cy="6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1767240" y="2019600"/>
              <a:ext cx="4104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 flipV="1">
              <a:off x="2102760" y="2020680"/>
              <a:ext cx="1440" cy="28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2082240" y="2021040"/>
              <a:ext cx="41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 flipV="1">
              <a:off x="2418120" y="2028600"/>
              <a:ext cx="1440" cy="15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2397600" y="2028960"/>
              <a:ext cx="41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 flipV="1">
              <a:off x="2729880" y="2014920"/>
              <a:ext cx="1440" cy="15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2709720" y="2015280"/>
              <a:ext cx="424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1004760" y="1153800"/>
              <a:ext cx="1080" cy="982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988920" y="213624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988920" y="197388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988920" y="180828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988920" y="164412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988920" y="148176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988920" y="131616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988920" y="115380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1004760" y="2136240"/>
              <a:ext cx="188280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 flipV="1">
              <a:off x="1004760" y="213588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 flipV="1">
              <a:off x="1317960" y="213588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 flipV="1">
              <a:off x="1631880" y="213588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 flipV="1">
              <a:off x="1946880" y="213588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 flipV="1">
              <a:off x="2262240" y="213588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 flipV="1">
              <a:off x="2575440" y="213588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 flipV="1">
              <a:off x="2889360" y="213588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1815120" y="961560"/>
              <a:ext cx="285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925200" y="20858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882360" y="19234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925200" y="17578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882360" y="15955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925200" y="14313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882360" y="12657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925200" y="11034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 rot="5400000">
              <a:off x="1081080" y="226512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 rot="5400000">
              <a:off x="1057320" y="223092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 rot="5400000">
              <a:off x="1393920" y="230076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 rot="5400000">
              <a:off x="1327320" y="23040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 rot="5400000">
              <a:off x="1344240" y="222696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 rot="5400000">
              <a:off x="1709280" y="230076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 rot="5400000">
              <a:off x="1640880" y="23040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 rot="5400000">
              <a:off x="1648080" y="22366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 rot="5400000">
              <a:off x="2013840" y="231372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 rot="5400000">
              <a:off x="1954440" y="23040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 rot="5400000">
              <a:off x="1955520" y="223992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 rot="5400000">
              <a:off x="2336400" y="230076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 rot="5400000">
              <a:off x="2268000" y="23040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 rot="5400000">
              <a:off x="2228040" y="228132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 rot="5400000">
              <a:off x="2650320" y="230076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 rot="5400000">
              <a:off x="2629080" y="226008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 rot="5400000">
              <a:off x="2564640" y="225900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 rot="16200000">
              <a:off x="664560" y="160308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13T19:27:41Z</dcterms:created>
  <dc:creator>CRUK CRUK</dc:creator>
  <dc:description/>
  <dc:language>en-US</dc:language>
  <cp:lastModifiedBy>CRUK CRUK</cp:lastModifiedBy>
  <dcterms:modified xsi:type="dcterms:W3CDTF">2009-01-13T19:29:45Z</dcterms:modified>
  <cp:revision>2</cp:revision>
  <dc:subject/>
  <dc:title>PowerPoint Presentation</dc:title>
</cp:coreProperties>
</file>